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FC943-14F4-49FD-AD98-33456437D668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AEBF7-57E1-4D4E-84DC-565818F1C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47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9ACD4E-FBD0-4A69-8A2D-42A9A272243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5263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975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476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983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81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267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083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87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364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01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238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631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27A3EF-F895-4CE2-8C14-D8DB483C34A4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67D0F0-5F95-484D-B0CA-A99219C2E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807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935DE88-DA3A-484C-1F97-3BE046878A3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6702" r="15445" b="10500"/>
          <a:stretch/>
        </p:blipFill>
        <p:spPr>
          <a:xfrm>
            <a:off x="575085" y="774700"/>
            <a:ext cx="2289400" cy="344678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E03513E-A6C6-8863-FB04-F75100F50E8A}"/>
              </a:ext>
            </a:extLst>
          </p:cNvPr>
          <p:cNvSpPr txBox="1"/>
          <p:nvPr/>
        </p:nvSpPr>
        <p:spPr>
          <a:xfrm rot="16200000">
            <a:off x="1614644" y="4659212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Pokkali</a:t>
            </a:r>
            <a:endParaRPr lang="en-US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7F88B7-F633-7ABE-C0ED-30D571AC35C3}"/>
              </a:ext>
            </a:extLst>
          </p:cNvPr>
          <p:cNvSpPr txBox="1"/>
          <p:nvPr/>
        </p:nvSpPr>
        <p:spPr>
          <a:xfrm rot="16200000">
            <a:off x="1165539" y="4714516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L5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9F9F59-4F71-964E-6E39-B604EDD755AB}"/>
              </a:ext>
            </a:extLst>
          </p:cNvPr>
          <p:cNvSpPr txBox="1"/>
          <p:nvPr/>
        </p:nvSpPr>
        <p:spPr>
          <a:xfrm rot="16200000">
            <a:off x="2243285" y="4783445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R2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25F1127-411B-A600-93F5-EDBAC40D33DF}"/>
              </a:ext>
            </a:extLst>
          </p:cNvPr>
          <p:cNvSpPr txBox="1"/>
          <p:nvPr/>
        </p:nvSpPr>
        <p:spPr>
          <a:xfrm rot="5400000">
            <a:off x="1849657" y="2313239"/>
            <a:ext cx="23374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ositive Metabolome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A4CC841-1060-75B7-5978-4B52DB5256C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6607" r="15445" b="10595"/>
          <a:stretch/>
        </p:blipFill>
        <p:spPr>
          <a:xfrm>
            <a:off x="3612372" y="774699"/>
            <a:ext cx="2289400" cy="344678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744AEFA-96B3-2C5F-4D8D-D98045357ABB}"/>
              </a:ext>
            </a:extLst>
          </p:cNvPr>
          <p:cNvSpPr txBox="1"/>
          <p:nvPr/>
        </p:nvSpPr>
        <p:spPr>
          <a:xfrm rot="16200000">
            <a:off x="4653179" y="333371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Pokkali</a:t>
            </a:r>
            <a:endParaRPr lang="en-US" sz="14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504DBBA-8746-6863-EB16-509114DAE999}"/>
              </a:ext>
            </a:extLst>
          </p:cNvPr>
          <p:cNvSpPr txBox="1"/>
          <p:nvPr/>
        </p:nvSpPr>
        <p:spPr>
          <a:xfrm rot="16200000">
            <a:off x="4204074" y="388675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L51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A3651D-E013-559B-2D6C-940878771694}"/>
              </a:ext>
            </a:extLst>
          </p:cNvPr>
          <p:cNvSpPr txBox="1"/>
          <p:nvPr/>
        </p:nvSpPr>
        <p:spPr>
          <a:xfrm rot="16200000">
            <a:off x="5281820" y="457604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R2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5EBB14-AFFD-A6BB-1837-1A064604F206}"/>
              </a:ext>
            </a:extLst>
          </p:cNvPr>
          <p:cNvSpPr txBox="1"/>
          <p:nvPr/>
        </p:nvSpPr>
        <p:spPr>
          <a:xfrm rot="5400000">
            <a:off x="4867005" y="2344200"/>
            <a:ext cx="2322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egative Metabolome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836702DE-FD8D-BCFB-DA58-23BFF375C462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-941" t="26650" r="16386" b="10551"/>
          <a:stretch/>
        </p:blipFill>
        <p:spPr>
          <a:xfrm>
            <a:off x="534669" y="5138421"/>
            <a:ext cx="2289400" cy="344678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43CFD5C-13D2-BCCF-2CC9-90F5747C0BD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26472" r="15445" b="10731"/>
          <a:stretch/>
        </p:blipFill>
        <p:spPr>
          <a:xfrm>
            <a:off x="3612372" y="5138419"/>
            <a:ext cx="2289400" cy="344678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7AB73D8-5B87-D6FC-39BF-5DD04DC88352}"/>
              </a:ext>
            </a:extLst>
          </p:cNvPr>
          <p:cNvSpPr txBox="1"/>
          <p:nvPr/>
        </p:nvSpPr>
        <p:spPr>
          <a:xfrm rot="5400000">
            <a:off x="1664775" y="6707922"/>
            <a:ext cx="2626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ositive Lipidom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07FE3F1-FE7E-BC36-DAB5-4EADA76B5560}"/>
              </a:ext>
            </a:extLst>
          </p:cNvPr>
          <p:cNvSpPr txBox="1"/>
          <p:nvPr/>
        </p:nvSpPr>
        <p:spPr>
          <a:xfrm rot="16200000">
            <a:off x="1624169" y="323462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Pokkali</a:t>
            </a:r>
            <a:endParaRPr lang="en-US" sz="1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2E17FFA-D1AE-4C73-C7E8-A3088EF4B0FD}"/>
              </a:ext>
            </a:extLst>
          </p:cNvPr>
          <p:cNvSpPr txBox="1"/>
          <p:nvPr/>
        </p:nvSpPr>
        <p:spPr>
          <a:xfrm rot="16200000">
            <a:off x="1175064" y="378766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L51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46BEA09-8681-C6ED-32C7-0F964F85EB64}"/>
              </a:ext>
            </a:extLst>
          </p:cNvPr>
          <p:cNvSpPr txBox="1"/>
          <p:nvPr/>
        </p:nvSpPr>
        <p:spPr>
          <a:xfrm rot="16200000">
            <a:off x="2252810" y="447695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R2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B23F738-CE87-5734-4707-8C87CD82945A}"/>
              </a:ext>
            </a:extLst>
          </p:cNvPr>
          <p:cNvSpPr txBox="1"/>
          <p:nvPr/>
        </p:nvSpPr>
        <p:spPr>
          <a:xfrm rot="5400000">
            <a:off x="4715010" y="6707923"/>
            <a:ext cx="2626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egative Lipidom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9FA8659-EB4E-DD66-DFD6-560E20C873DA}"/>
              </a:ext>
            </a:extLst>
          </p:cNvPr>
          <p:cNvSpPr txBox="1"/>
          <p:nvPr/>
        </p:nvSpPr>
        <p:spPr>
          <a:xfrm rot="16200000">
            <a:off x="5286488" y="4783445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R29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EEA956D-EA7E-A8FD-9A8D-C457EF6BCA7C}"/>
              </a:ext>
            </a:extLst>
          </p:cNvPr>
          <p:cNvSpPr txBox="1"/>
          <p:nvPr/>
        </p:nvSpPr>
        <p:spPr>
          <a:xfrm rot="16200000">
            <a:off x="4182140" y="4692231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Pokkali</a:t>
            </a:r>
            <a:endParaRPr lang="en-US" sz="14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78E0439-94FD-9313-176C-F00CC478906F}"/>
              </a:ext>
            </a:extLst>
          </p:cNvPr>
          <p:cNvSpPr txBox="1"/>
          <p:nvPr/>
        </p:nvSpPr>
        <p:spPr>
          <a:xfrm rot="16200000">
            <a:off x="4744647" y="4714516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L5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62E320-406C-4DCB-A87E-C2B60953477C}"/>
              </a:ext>
            </a:extLst>
          </p:cNvPr>
          <p:cNvSpPr txBox="1"/>
          <p:nvPr/>
        </p:nvSpPr>
        <p:spPr>
          <a:xfrm>
            <a:off x="376354" y="43739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FDD7159-74CF-5402-98BA-DD8F0D3C7039}"/>
              </a:ext>
            </a:extLst>
          </p:cNvPr>
          <p:cNvSpPr txBox="1"/>
          <p:nvPr/>
        </p:nvSpPr>
        <p:spPr>
          <a:xfrm>
            <a:off x="399396" y="43333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03EE51-9512-EA30-6EF7-93A5A849D537}"/>
              </a:ext>
            </a:extLst>
          </p:cNvPr>
          <p:cNvSpPr txBox="1"/>
          <p:nvPr/>
        </p:nvSpPr>
        <p:spPr>
          <a:xfrm>
            <a:off x="3488835" y="43739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5070425-4DE5-E518-1BC8-0F77CA2354FE}"/>
              </a:ext>
            </a:extLst>
          </p:cNvPr>
          <p:cNvSpPr txBox="1"/>
          <p:nvPr/>
        </p:nvSpPr>
        <p:spPr>
          <a:xfrm>
            <a:off x="3488835" y="4333321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8E28B58-8496-6AB6-2069-3B1F2F5E477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505" t="17252" r="69644" b="78768"/>
          <a:stretch/>
        </p:blipFill>
        <p:spPr>
          <a:xfrm>
            <a:off x="2959159" y="8432218"/>
            <a:ext cx="1046128" cy="36933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44B170D-16A3-A925-1B59-36C317D2E8A4}"/>
              </a:ext>
            </a:extLst>
          </p:cNvPr>
          <p:cNvSpPr txBox="1"/>
          <p:nvPr/>
        </p:nvSpPr>
        <p:spPr>
          <a:xfrm>
            <a:off x="3010455" y="8718408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    0   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FDD9E37-8D1D-2836-E2A8-81387FB842FE}"/>
              </a:ext>
            </a:extLst>
          </p:cNvPr>
          <p:cNvSpPr txBox="1"/>
          <p:nvPr/>
        </p:nvSpPr>
        <p:spPr>
          <a:xfrm>
            <a:off x="2954674" y="8879354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ow Z-score</a:t>
            </a:r>
          </a:p>
        </p:txBody>
      </p:sp>
    </p:spTree>
    <p:extLst>
      <p:ext uri="{BB962C8B-B14F-4D97-AF65-F5344CB8AC3E}">
        <p14:creationId xmlns:p14="http://schemas.microsoft.com/office/powerpoint/2010/main" val="1648988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</Words>
  <Application>Microsoft Office PowerPoint</Application>
  <PresentationFormat>Letter Paper (8.5x11 in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buayon, Isaiah</dc:creator>
  <cp:lastModifiedBy>Pabuayon, Isaiah</cp:lastModifiedBy>
  <cp:revision>1</cp:revision>
  <dcterms:created xsi:type="dcterms:W3CDTF">2025-07-07T21:37:19Z</dcterms:created>
  <dcterms:modified xsi:type="dcterms:W3CDTF">2025-07-07T21:37:36Z</dcterms:modified>
</cp:coreProperties>
</file>